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 autoAdjust="0"/>
    <p:restoredTop sz="94660"/>
  </p:normalViewPr>
  <p:slideViewPr>
    <p:cSldViewPr snapToGrid="0" showGuides="1">
      <p:cViewPr varScale="1">
        <p:scale>
          <a:sx n="50" d="100"/>
          <a:sy n="50" d="100"/>
        </p:scale>
        <p:origin x="522" y="3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990038-FD18-0778-A8CB-B135DBE0AA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41DD3A8-FEDA-CA25-660D-FA4BE597BB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84B872-028A-1885-1908-18F8DC37F3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925B2-4F4B-46AD-8085-C51DC5735632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18DE9F-88C6-267F-9650-CB9101457E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A33D4D-9197-8B64-996C-BB4401112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A3E5A-683F-4549-9004-CB6786D0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958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58E829-7506-BE00-8C1A-E41BA81DBF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777443-E07C-89BC-C08A-A768F07CF7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A195A3-0366-94AC-205C-D35F3EAF3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925B2-4F4B-46AD-8085-C51DC5735632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DDA458-A2E2-5DD9-A0D8-EF2906BE2B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A489BE-1353-B17D-52C9-35EB9FE53C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A3E5A-683F-4549-9004-CB6786D0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8572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A9252F9-29CF-D355-DF14-54602F9BDC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587876-DEA6-447E-2ABA-D16D126741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25503B-CF4E-33FB-6532-6CD4C5BCD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925B2-4F4B-46AD-8085-C51DC5735632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ED970E-4F1E-FD56-0975-B0FD0E50C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5C350A-0C83-CEEE-25D3-48486597C5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A3E5A-683F-4549-9004-CB6786D0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371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8472CB-A29F-5303-1472-44162CB3E9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84E5D7-BED8-990D-3BA5-E894E78944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A928F0-BECD-EB4B-9FF6-97B697C70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925B2-4F4B-46AD-8085-C51DC5735632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A3143F-69D6-D263-5397-70521636A8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928219-5273-0010-CE8C-32C34B1D8C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A3E5A-683F-4549-9004-CB6786D0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160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1C7BCD-390A-3820-10E0-6BD8D8ABB7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D87C29-FDF7-C6D0-E049-E4FB93A5CF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51DECD-6AB0-1F2B-B91A-E2F547ABA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925B2-4F4B-46AD-8085-C51DC5735632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1526A0-0615-3BFB-1A6F-7CFD7EBCC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8CBA5F-6756-ADE9-F0B2-BEA21730F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A3E5A-683F-4549-9004-CB6786D0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658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605623-DF41-4A42-D614-82E07C0207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45037A-A480-E435-56E4-255362E03C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981518-D73F-70A4-DDE7-3BF52214FB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C4F19B-A715-90B7-3790-622EEC102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925B2-4F4B-46AD-8085-C51DC5735632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2B678C-7F59-F84F-5DE5-236A44E9F0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B38C6E-DFDD-2944-218B-17420BA81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A3E5A-683F-4549-9004-CB6786D0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932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583C1E-081A-4630-5ED2-54B8469AE5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D2ACA2-959B-EB5F-1282-229F256B85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AE4383-7866-3292-4702-9CE9D78C65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48915EC-C56F-E0AC-119A-3C9019A5D2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0E8115-C2BD-3357-BA03-4FABF48BC8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5AEE3E-DD99-D92C-F40C-5431608B7F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925B2-4F4B-46AD-8085-C51DC5735632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CBC7F0A-62E0-40F8-2F0E-DF50AD423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D6C1895-C9D4-ABBD-62D3-100331AD1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A3E5A-683F-4549-9004-CB6786D0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083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7603B2-2C9D-6D72-71BF-BB5EBE4CD5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9449412-ECDD-FF9F-BB07-59DF942AE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925B2-4F4B-46AD-8085-C51DC5735632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2AEE02-9B58-D34C-75C1-C44403416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25FEBD-AF4D-44AE-E81F-A72D46502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A3E5A-683F-4549-9004-CB6786D0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122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9406252-CC70-2FBE-C658-9119D6B11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925B2-4F4B-46AD-8085-C51DC5735632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CDC259-B0BD-BCEF-1D70-0BB98D3370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8A0341B-4564-4D3E-546F-5E90F780E5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A3E5A-683F-4549-9004-CB6786D0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802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70DEB2-257C-7E12-740E-A0A2CD1799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B1FFF4-D756-83E4-B7B0-90C4BB288B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38883B-705C-DA53-95A3-592E77614D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25D112-6BEB-3442-500A-00472F51C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925B2-4F4B-46AD-8085-C51DC5735632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B71126-6059-1D1A-9F82-0710F102F3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E3E2B3-7147-8079-443D-2E8D98712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A3E5A-683F-4549-9004-CB6786D0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797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58B91A-EC80-50B0-B53B-2A1AD49B1B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89350B2-EC3A-803C-C758-AE59FB03D5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C2D052-672C-D36E-0A10-5445E21B67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5D6F61-76A6-7D69-A9ED-D397A6AA5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8925B2-4F4B-46AD-8085-C51DC5735632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9D78E7-922B-DBFF-6598-DADBF62FEC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195A65-4916-B366-A569-B580F4F2CB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A3E5A-683F-4549-9004-CB6786D0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777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8068D76-162B-1F04-85F8-526E2F2331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4E64FB-4613-3C6F-CB7E-B7DD7561D0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35DFDC-822D-9F66-80B5-B0BD1C5627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8925B2-4F4B-46AD-8085-C51DC5735632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A674C5-4341-2D6F-B7CE-E6841F53A79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D07D23-DB7D-2B12-D634-A68207A442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4A3E5A-683F-4549-9004-CB6786D0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451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2DAD6E-ACA2-D8E1-B25B-4441982858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930399"/>
            <a:ext cx="9144000" cy="1579563"/>
          </a:xfrm>
        </p:spPr>
        <p:txBody>
          <a:bodyPr anchor="ctr">
            <a:normAutofit/>
          </a:bodyPr>
          <a:lstStyle/>
          <a:p>
            <a:r>
              <a:rPr lang="en-US" sz="28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Sophoraflavanone</a:t>
            </a:r>
            <a:r>
              <a:rPr lang="en-US" sz="2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G from </a:t>
            </a:r>
            <a:r>
              <a:rPr lang="en-US" sz="28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Phit</a:t>
            </a:r>
            <a:r>
              <a:rPr lang="en-US" sz="2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-Sanat (</a:t>
            </a:r>
            <a:r>
              <a:rPr lang="en-US" sz="28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Sophora </a:t>
            </a:r>
            <a:r>
              <a:rPr lang="en-US" sz="2800" b="1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exigua</a:t>
            </a:r>
            <a:r>
              <a:rPr lang="en-US" sz="2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</a:t>
            </a:r>
            <a:r>
              <a:rPr lang="en-US" sz="28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Craib</a:t>
            </a:r>
            <a:r>
              <a:rPr lang="en-US" sz="2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) Inhibits WT1 Protein Expression and Induces Cell Cycle Arrest and Apoptosis in Acute Myeloid Leukemia</a:t>
            </a:r>
            <a:endParaRPr lang="en-US" sz="28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D47544F-C3A4-C171-B554-D58CA39AFF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429000"/>
            <a:ext cx="9144000" cy="1655762"/>
          </a:xfrm>
        </p:spPr>
        <p:txBody>
          <a:bodyPr anchor="ctr"/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Lapamas Rueankham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Lokadi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Pierre Luhata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2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Paware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Panyajai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Natsim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Viriyaadhammaa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Sawitree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Chiampanichayakul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1,3,4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Methee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Rungrojsakol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5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Trinnakorn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Katekunlaphan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6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Siriporn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Okonogi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4,7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Pronngarm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Dejkriengkraikul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8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Aroonchai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Saiai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9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Toyonobu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Usuki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2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, Colleen Sweeney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10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,* and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Songyo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Anuchapreeda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1,3,4,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*</a:t>
            </a:r>
            <a:endParaRPr lang="en-US" sz="18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Cordia New" panose="020B0304020202020204" pitchFamily="34" charset="-34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70D2785-B4D6-0CEB-FBFD-DB5758B9C3EA}"/>
              </a:ext>
            </a:extLst>
          </p:cNvPr>
          <p:cNvSpPr txBox="1"/>
          <p:nvPr/>
        </p:nvSpPr>
        <p:spPr>
          <a:xfrm>
            <a:off x="1198880" y="1376698"/>
            <a:ext cx="9794240" cy="523220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 marL="0" marR="0" indent="0" algn="ctr">
              <a:spcBef>
                <a:spcPts val="0"/>
              </a:spcBef>
              <a:spcAft>
                <a:spcPts val="0"/>
              </a:spcAft>
            </a:pPr>
            <a:r>
              <a:rPr lang="en-US" sz="2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SUPPLEMENTARY INFORMATION</a:t>
            </a:r>
            <a:endParaRPr lang="en-US" sz="2800" dirty="0">
              <a:effectLst/>
              <a:latin typeface="Times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33823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680642D-44B9-9825-21EC-E8E4F7D69527}"/>
              </a:ext>
            </a:extLst>
          </p:cNvPr>
          <p:cNvSpPr txBox="1"/>
          <p:nvPr/>
        </p:nvSpPr>
        <p:spPr>
          <a:xfrm>
            <a:off x="162560" y="6435937"/>
            <a:ext cx="119546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S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upplementary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figure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1.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(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) HMBC, (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b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) HMQC, and (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c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)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HSQC NMR s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pectrums </a:t>
            </a:r>
            <a:r>
              <a:rPr lang="en-US" sz="180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of SG. </a:t>
            </a:r>
            <a:endParaRPr lang="en-US" sz="16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Cordia New" panose="020B0304020202020204" pitchFamily="34" charset="-34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81D3384-42EF-EF50-B0EB-607E0FDDCF2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70" r="23095" b="9336"/>
          <a:stretch/>
        </p:blipFill>
        <p:spPr bwMode="auto">
          <a:xfrm>
            <a:off x="1350112" y="63886"/>
            <a:ext cx="4314641" cy="3180448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E4A2C40-E1C4-9104-8B5F-8E65DFC50E2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342" r="23378" b="9139"/>
          <a:stretch/>
        </p:blipFill>
        <p:spPr bwMode="auto">
          <a:xfrm>
            <a:off x="6527248" y="63886"/>
            <a:ext cx="4293152" cy="3180448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4C70336-18E5-3193-53E1-F82328F8FED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204" r="23095" b="9740"/>
          <a:stretch/>
        </p:blipFill>
        <p:spPr bwMode="auto">
          <a:xfrm>
            <a:off x="3779236" y="3229913"/>
            <a:ext cx="4314641" cy="3206024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6410D4C-C3FD-E767-DAFF-50F094C17A58}"/>
              </a:ext>
            </a:extLst>
          </p:cNvPr>
          <p:cNvSpPr txBox="1"/>
          <p:nvPr/>
        </p:nvSpPr>
        <p:spPr>
          <a:xfrm>
            <a:off x="917630" y="0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9C732E-07C2-4BE6-63C0-B62D7DE91D0A}"/>
              </a:ext>
            </a:extLst>
          </p:cNvPr>
          <p:cNvSpPr txBox="1"/>
          <p:nvPr/>
        </p:nvSpPr>
        <p:spPr>
          <a:xfrm>
            <a:off x="6221150" y="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74A1C45-95D8-73D5-487B-01545145A5D0}"/>
              </a:ext>
            </a:extLst>
          </p:cNvPr>
          <p:cNvSpPr txBox="1"/>
          <p:nvPr/>
        </p:nvSpPr>
        <p:spPr>
          <a:xfrm>
            <a:off x="3325266" y="3244335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30612810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100</Words>
  <Application>Microsoft Office PowerPoint</Application>
  <PresentationFormat>Widescreen</PresentationFormat>
  <Paragraphs>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Times</vt:lpstr>
      <vt:lpstr>Times New Roman</vt:lpstr>
      <vt:lpstr>Office Theme</vt:lpstr>
      <vt:lpstr>Sophoraflavanone G from Phit-Sanat (Sophora exigua Craib) Inhibits WT1 Protein Expression and Induces Cell Cycle Arrest and Apoptosis in Acute Myeloid Leukemi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apamas Rueankham</dc:creator>
  <cp:lastModifiedBy>SONGYOT ANUCHAPREEDA</cp:lastModifiedBy>
  <cp:revision>7</cp:revision>
  <dcterms:created xsi:type="dcterms:W3CDTF">2024-09-01T16:36:02Z</dcterms:created>
  <dcterms:modified xsi:type="dcterms:W3CDTF">2024-09-12T04:26:34Z</dcterms:modified>
</cp:coreProperties>
</file>